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66467-E930-4849-B3FC-1DD5419177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19507-52D4-4EF4-A295-D3DF71D48E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00AD1-94BC-4877-8F8A-E7B58A6102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8A580-B0D5-4098-AF7D-F61A4A5927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322EA-3B02-48CE-AC12-E81AFE4845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DB60D-9FA1-4AB4-8B54-704E28E74E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6BDE6-9D7E-46CE-AD9A-DAE0FC0650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16897-0D80-44E6-AF4C-A85C14431B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FBCFE-BCB3-4C88-8E14-06C01C808B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3348F-4527-4E21-BCCB-7D3171CCFA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61254-70FD-4A99-9295-43483812C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57601-C219-43FC-BB68-5CF558CA0D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6A1A13-BFD8-4100-B02D-D014DE57438A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19" descr=""/>
          <p:cNvPicPr/>
          <p:nvPr/>
        </p:nvPicPr>
        <p:blipFill>
          <a:blip r:embed="rId1"/>
          <a:stretch/>
        </p:blipFill>
        <p:spPr>
          <a:xfrm>
            <a:off x="2644920" y="487440"/>
            <a:ext cx="1226880" cy="11034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16"/>
          <p:cNvSpPr/>
          <p:nvPr/>
        </p:nvSpPr>
        <p:spPr>
          <a:xfrm>
            <a:off x="4349880" y="210960"/>
            <a:ext cx="132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FGFR3-III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 Box 14"/>
          <p:cNvSpPr/>
          <p:nvPr/>
        </p:nvSpPr>
        <p:spPr>
          <a:xfrm>
            <a:off x="1803240" y="212760"/>
            <a:ext cx="84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Text Box 15"/>
          <p:cNvSpPr/>
          <p:nvPr/>
        </p:nvSpPr>
        <p:spPr>
          <a:xfrm>
            <a:off x="3022560" y="212760"/>
            <a:ext cx="132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FGFR3-III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5" name="Group 190"/>
          <p:cNvGrpSpPr/>
          <p:nvPr/>
        </p:nvGrpSpPr>
        <p:grpSpPr>
          <a:xfrm>
            <a:off x="1109520" y="1627200"/>
            <a:ext cx="4313160" cy="1737000"/>
            <a:chOff x="1109520" y="1627200"/>
            <a:chExt cx="4313160" cy="1737000"/>
          </a:xfrm>
        </p:grpSpPr>
        <p:pic>
          <p:nvPicPr>
            <p:cNvPr id="46" name="Picture 188" descr=""/>
            <p:cNvPicPr/>
            <p:nvPr/>
          </p:nvPicPr>
          <p:blipFill>
            <a:blip r:embed="rId2"/>
            <a:stretch/>
          </p:blipFill>
          <p:spPr>
            <a:xfrm>
              <a:off x="3874320" y="1648800"/>
              <a:ext cx="1254960" cy="1335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86" descr=""/>
            <p:cNvPicPr/>
            <p:nvPr/>
          </p:nvPicPr>
          <p:blipFill>
            <a:blip r:embed="rId3"/>
            <a:stretch/>
          </p:blipFill>
          <p:spPr>
            <a:xfrm>
              <a:off x="2515680" y="1656360"/>
              <a:ext cx="1213200" cy="133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185" descr=""/>
            <p:cNvPicPr/>
            <p:nvPr/>
          </p:nvPicPr>
          <p:blipFill>
            <a:blip r:embed="rId4"/>
            <a:stretch/>
          </p:blipFill>
          <p:spPr>
            <a:xfrm>
              <a:off x="1303200" y="1658880"/>
              <a:ext cx="1209240" cy="1363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 Box 11"/>
            <p:cNvSpPr/>
            <p:nvPr/>
          </p:nvSpPr>
          <p:spPr>
            <a:xfrm rot="16200000">
              <a:off x="820080" y="2163960"/>
              <a:ext cx="82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Count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0" name="Group 12"/>
            <p:cNvGrpSpPr/>
            <p:nvPr/>
          </p:nvGrpSpPr>
          <p:grpSpPr>
            <a:xfrm>
              <a:off x="1283040" y="2963880"/>
              <a:ext cx="1282320" cy="400320"/>
              <a:chOff x="1283040" y="2963880"/>
              <a:chExt cx="1282320" cy="400320"/>
            </a:xfrm>
          </p:grpSpPr>
          <p:sp>
            <p:nvSpPr>
              <p:cNvPr id="51" name="Text Box 13"/>
              <p:cNvSpPr/>
              <p:nvPr/>
            </p:nvSpPr>
            <p:spPr>
              <a:xfrm>
                <a:off x="1283040" y="2963880"/>
                <a:ext cx="570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Text Box 14"/>
              <p:cNvSpPr/>
              <p:nvPr/>
            </p:nvSpPr>
            <p:spPr>
              <a:xfrm>
                <a:off x="1567440" y="3117960"/>
                <a:ext cx="57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Text Box 15"/>
              <p:cNvSpPr/>
              <p:nvPr/>
            </p:nvSpPr>
            <p:spPr>
              <a:xfrm>
                <a:off x="1994760" y="3114360"/>
                <a:ext cx="570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Text Box 16"/>
              <p:cNvSpPr/>
              <p:nvPr/>
            </p:nvSpPr>
            <p:spPr>
              <a:xfrm>
                <a:off x="1830600" y="2965320"/>
                <a:ext cx="509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AutoShape 17"/>
              <p:cNvSpPr/>
              <p:nvPr/>
            </p:nvSpPr>
            <p:spPr>
              <a:xfrm rot="5400000">
                <a:off x="1555560" y="2840040"/>
                <a:ext cx="39600" cy="294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14760 h 294480"/>
                  <a:gd name="textAreaBottom" fmla="*/ 279720 h 294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102"/>
                      <a:pt x="21600" y="2204"/>
                    </a:cubicBezTo>
                    <a:lnTo>
                      <a:pt x="21600" y="19396"/>
                    </a:lnTo>
                    <a:cubicBezTo>
                      <a:pt x="21600" y="20498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AutoShape 18"/>
              <p:cNvSpPr/>
              <p:nvPr/>
            </p:nvSpPr>
            <p:spPr>
              <a:xfrm rot="5400000">
                <a:off x="1846800" y="2842200"/>
                <a:ext cx="40680" cy="288720"/>
              </a:xfrm>
              <a:custGeom>
                <a:avLst/>
                <a:gdLst>
                  <a:gd name="textAreaLeft" fmla="*/ 0 w 40680"/>
                  <a:gd name="textAreaRight" fmla="*/ 28440 w 40680"/>
                  <a:gd name="textAreaTop" fmla="*/ 9000 h 288720"/>
                  <a:gd name="textAreaBottom" fmla="*/ 279720 h 2887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94"/>
                      <a:pt x="21600" y="1388"/>
                    </a:cubicBezTo>
                    <a:lnTo>
                      <a:pt x="21600" y="20212"/>
                    </a:lnTo>
                    <a:cubicBezTo>
                      <a:pt x="21600" y="20906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AutoShape 19"/>
              <p:cNvSpPr/>
              <p:nvPr/>
            </p:nvSpPr>
            <p:spPr>
              <a:xfrm rot="5400000">
                <a:off x="2064240" y="2846520"/>
                <a:ext cx="34200" cy="28584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8280 h 285840"/>
                  <a:gd name="textAreaBottom" fmla="*/ 277560 h 2858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51"/>
                      <a:pt x="21600" y="1302"/>
                    </a:cubicBezTo>
                    <a:lnTo>
                      <a:pt x="21600" y="20298"/>
                    </a:lnTo>
                    <a:cubicBezTo>
                      <a:pt x="21600" y="20949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AutoShape 20"/>
              <p:cNvSpPr/>
              <p:nvPr/>
            </p:nvSpPr>
            <p:spPr>
              <a:xfrm rot="5400000">
                <a:off x="2272680" y="2846520"/>
                <a:ext cx="34200" cy="28620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8280 h 286200"/>
                  <a:gd name="textAreaBottom" fmla="*/ 277920 h 286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51"/>
                      <a:pt x="21600" y="1302"/>
                    </a:cubicBezTo>
                    <a:lnTo>
                      <a:pt x="21600" y="20298"/>
                    </a:lnTo>
                    <a:cubicBezTo>
                      <a:pt x="21600" y="20949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Line 21"/>
              <p:cNvSpPr/>
              <p:nvPr/>
            </p:nvSpPr>
            <p:spPr>
              <a:xfrm>
                <a:off x="1868400" y="300708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Line 22"/>
              <p:cNvSpPr/>
              <p:nvPr/>
            </p:nvSpPr>
            <p:spPr>
              <a:xfrm>
                <a:off x="2288160" y="300708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61" name="Group 23"/>
            <p:cNvGrpSpPr/>
            <p:nvPr/>
          </p:nvGrpSpPr>
          <p:grpSpPr>
            <a:xfrm>
              <a:off x="2522880" y="2958840"/>
              <a:ext cx="1262160" cy="400320"/>
              <a:chOff x="2522880" y="2958840"/>
              <a:chExt cx="1262160" cy="400320"/>
            </a:xfrm>
          </p:grpSpPr>
          <p:sp>
            <p:nvSpPr>
              <p:cNvPr id="62" name="Text Box 24"/>
              <p:cNvSpPr/>
              <p:nvPr/>
            </p:nvSpPr>
            <p:spPr>
              <a:xfrm>
                <a:off x="2522880" y="2958840"/>
                <a:ext cx="56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Text Box 25"/>
              <p:cNvSpPr/>
              <p:nvPr/>
            </p:nvSpPr>
            <p:spPr>
              <a:xfrm>
                <a:off x="2802960" y="3112920"/>
                <a:ext cx="56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Text Box 26"/>
              <p:cNvSpPr/>
              <p:nvPr/>
            </p:nvSpPr>
            <p:spPr>
              <a:xfrm>
                <a:off x="3223440" y="3109320"/>
                <a:ext cx="56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Text Box 27"/>
              <p:cNvSpPr/>
              <p:nvPr/>
            </p:nvSpPr>
            <p:spPr>
              <a:xfrm>
                <a:off x="3061800" y="2960280"/>
                <a:ext cx="50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AutoShape 28"/>
              <p:cNvSpPr/>
              <p:nvPr/>
            </p:nvSpPr>
            <p:spPr>
              <a:xfrm rot="5400000">
                <a:off x="2791440" y="2833920"/>
                <a:ext cx="39240" cy="294120"/>
              </a:xfrm>
              <a:custGeom>
                <a:avLst/>
                <a:gdLst>
                  <a:gd name="textAreaLeft" fmla="*/ 0 w 39240"/>
                  <a:gd name="textAreaRight" fmla="*/ 27720 w 39240"/>
                  <a:gd name="textAreaTop" fmla="*/ 14760 h 294120"/>
                  <a:gd name="textAreaBottom" fmla="*/ 279360 h 2941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86"/>
                      <a:pt x="21600" y="2172"/>
                    </a:cubicBezTo>
                    <a:lnTo>
                      <a:pt x="21600" y="19428"/>
                    </a:lnTo>
                    <a:cubicBezTo>
                      <a:pt x="21600" y="20514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AutoShape 29"/>
              <p:cNvSpPr/>
              <p:nvPr/>
            </p:nvSpPr>
            <p:spPr>
              <a:xfrm rot="5400000">
                <a:off x="3076920" y="2836800"/>
                <a:ext cx="40680" cy="289800"/>
              </a:xfrm>
              <a:custGeom>
                <a:avLst/>
                <a:gdLst>
                  <a:gd name="textAreaLeft" fmla="*/ 0 w 40680"/>
                  <a:gd name="textAreaRight" fmla="*/ 28440 w 40680"/>
                  <a:gd name="textAreaTop" fmla="*/ 9000 h 289800"/>
                  <a:gd name="textAreaBottom" fmla="*/ 280800 h 2898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81"/>
                      <a:pt x="21600" y="1361"/>
                    </a:cubicBezTo>
                    <a:lnTo>
                      <a:pt x="21600" y="20239"/>
                    </a:lnTo>
                    <a:cubicBezTo>
                      <a:pt x="21600" y="20920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AutoShape 30"/>
              <p:cNvSpPr/>
              <p:nvPr/>
            </p:nvSpPr>
            <p:spPr>
              <a:xfrm rot="5400000">
                <a:off x="3290760" y="2842560"/>
                <a:ext cx="34560" cy="286920"/>
              </a:xfrm>
              <a:custGeom>
                <a:avLst/>
                <a:gdLst>
                  <a:gd name="textAreaLeft" fmla="*/ 0 w 34560"/>
                  <a:gd name="textAreaRight" fmla="*/ 24480 w 34560"/>
                  <a:gd name="textAreaTop" fmla="*/ 8280 h 286920"/>
                  <a:gd name="textAreaBottom" fmla="*/ 278640 h 286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39"/>
                      <a:pt x="21600" y="1277"/>
                    </a:cubicBezTo>
                    <a:lnTo>
                      <a:pt x="21600" y="20323"/>
                    </a:lnTo>
                    <a:cubicBezTo>
                      <a:pt x="21600" y="20962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AutoShape 31"/>
              <p:cNvSpPr/>
              <p:nvPr/>
            </p:nvSpPr>
            <p:spPr>
              <a:xfrm rot="5400000">
                <a:off x="3495960" y="2842560"/>
                <a:ext cx="34560" cy="286920"/>
              </a:xfrm>
              <a:custGeom>
                <a:avLst/>
                <a:gdLst>
                  <a:gd name="textAreaLeft" fmla="*/ 0 w 34560"/>
                  <a:gd name="textAreaRight" fmla="*/ 24480 w 34560"/>
                  <a:gd name="textAreaTop" fmla="*/ 8280 h 286920"/>
                  <a:gd name="textAreaBottom" fmla="*/ 278640 h 286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39"/>
                      <a:pt x="21600" y="1277"/>
                    </a:cubicBezTo>
                    <a:lnTo>
                      <a:pt x="21600" y="20323"/>
                    </a:lnTo>
                    <a:cubicBezTo>
                      <a:pt x="21600" y="20962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Line 32"/>
              <p:cNvSpPr/>
              <p:nvPr/>
            </p:nvSpPr>
            <p:spPr>
              <a:xfrm>
                <a:off x="3098880" y="300204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Line 33"/>
              <p:cNvSpPr/>
              <p:nvPr/>
            </p:nvSpPr>
            <p:spPr>
              <a:xfrm>
                <a:off x="3511800" y="300204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72" name="Group 34"/>
            <p:cNvGrpSpPr/>
            <p:nvPr/>
          </p:nvGrpSpPr>
          <p:grpSpPr>
            <a:xfrm>
              <a:off x="3870000" y="2945880"/>
              <a:ext cx="1227240" cy="400320"/>
              <a:chOff x="3870000" y="2945880"/>
              <a:chExt cx="1227240" cy="400320"/>
            </a:xfrm>
          </p:grpSpPr>
          <p:sp>
            <p:nvSpPr>
              <p:cNvPr id="73" name="Text Box 35"/>
              <p:cNvSpPr/>
              <p:nvPr/>
            </p:nvSpPr>
            <p:spPr>
              <a:xfrm>
                <a:off x="3870000" y="2945880"/>
                <a:ext cx="546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Text Box 36"/>
              <p:cNvSpPr/>
              <p:nvPr/>
            </p:nvSpPr>
            <p:spPr>
              <a:xfrm>
                <a:off x="4142160" y="3099960"/>
                <a:ext cx="54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Text Box 37"/>
              <p:cNvSpPr/>
              <p:nvPr/>
            </p:nvSpPr>
            <p:spPr>
              <a:xfrm>
                <a:off x="4551120" y="3096360"/>
                <a:ext cx="546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Text Box 38"/>
              <p:cNvSpPr/>
              <p:nvPr/>
            </p:nvSpPr>
            <p:spPr>
              <a:xfrm>
                <a:off x="4394160" y="2947320"/>
                <a:ext cx="487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AutoShape 39"/>
              <p:cNvSpPr/>
              <p:nvPr/>
            </p:nvSpPr>
            <p:spPr>
              <a:xfrm rot="5400000">
                <a:off x="4130640" y="2820960"/>
                <a:ext cx="39600" cy="294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14400 h 294480"/>
                  <a:gd name="textAreaBottom" fmla="*/ 280080 h 294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56"/>
                      <a:pt x="21600" y="2111"/>
                    </a:cubicBezTo>
                    <a:lnTo>
                      <a:pt x="21600" y="19489"/>
                    </a:lnTo>
                    <a:cubicBezTo>
                      <a:pt x="21600" y="20545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AutoShape 40"/>
              <p:cNvSpPr/>
              <p:nvPr/>
            </p:nvSpPr>
            <p:spPr>
              <a:xfrm rot="5400000">
                <a:off x="4409280" y="2823120"/>
                <a:ext cx="40680" cy="289080"/>
              </a:xfrm>
              <a:custGeom>
                <a:avLst/>
                <a:gdLst>
                  <a:gd name="textAreaLeft" fmla="*/ 0 w 40680"/>
                  <a:gd name="textAreaRight" fmla="*/ 28440 w 40680"/>
                  <a:gd name="textAreaTop" fmla="*/ 8640 h 289080"/>
                  <a:gd name="textAreaBottom" fmla="*/ 280440 h 2890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65"/>
                      <a:pt x="21600" y="1329"/>
                    </a:cubicBezTo>
                    <a:lnTo>
                      <a:pt x="21600" y="20271"/>
                    </a:lnTo>
                    <a:cubicBezTo>
                      <a:pt x="21600" y="20936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AutoShape 41"/>
              <p:cNvSpPr/>
              <p:nvPr/>
            </p:nvSpPr>
            <p:spPr>
              <a:xfrm rot="5400000">
                <a:off x="4617720" y="2828520"/>
                <a:ext cx="34200" cy="28620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920 h 286200"/>
                  <a:gd name="textAreaBottom" fmla="*/ 278280 h 286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23"/>
                      <a:pt x="21600" y="1246"/>
                    </a:cubicBezTo>
                    <a:lnTo>
                      <a:pt x="21600" y="20354"/>
                    </a:lnTo>
                    <a:cubicBezTo>
                      <a:pt x="21600" y="20977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AutoShape 42"/>
              <p:cNvSpPr/>
              <p:nvPr/>
            </p:nvSpPr>
            <p:spPr>
              <a:xfrm rot="5400000">
                <a:off x="4817160" y="2828520"/>
                <a:ext cx="34200" cy="28620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920 h 286200"/>
                  <a:gd name="textAreaBottom" fmla="*/ 278280 h 286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23"/>
                      <a:pt x="21600" y="1246"/>
                    </a:cubicBezTo>
                    <a:lnTo>
                      <a:pt x="21600" y="20354"/>
                    </a:lnTo>
                    <a:cubicBezTo>
                      <a:pt x="21600" y="20977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Line 43"/>
              <p:cNvSpPr/>
              <p:nvPr/>
            </p:nvSpPr>
            <p:spPr>
              <a:xfrm>
                <a:off x="4430160" y="298908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Line 44"/>
              <p:cNvSpPr/>
              <p:nvPr/>
            </p:nvSpPr>
            <p:spPr>
              <a:xfrm>
                <a:off x="4831920" y="298908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3" name="Group 45"/>
            <p:cNvGrpSpPr/>
            <p:nvPr/>
          </p:nvGrpSpPr>
          <p:grpSpPr>
            <a:xfrm>
              <a:off x="1733400" y="1635840"/>
              <a:ext cx="931320" cy="496080"/>
              <a:chOff x="1733400" y="1635840"/>
              <a:chExt cx="931320" cy="496080"/>
            </a:xfrm>
          </p:grpSpPr>
          <p:sp>
            <p:nvSpPr>
              <p:cNvPr id="84" name="Text Box 46"/>
              <p:cNvSpPr/>
              <p:nvPr/>
            </p:nvSpPr>
            <p:spPr>
              <a:xfrm>
                <a:off x="1733400" y="1635840"/>
                <a:ext cx="845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8.9%±1.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Text Box 47"/>
              <p:cNvSpPr/>
              <p:nvPr/>
            </p:nvSpPr>
            <p:spPr>
              <a:xfrm>
                <a:off x="1812240" y="1728360"/>
                <a:ext cx="845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66.3%±0.6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Text Box 48"/>
              <p:cNvSpPr/>
              <p:nvPr/>
            </p:nvSpPr>
            <p:spPr>
              <a:xfrm>
                <a:off x="1819440" y="1832040"/>
                <a:ext cx="845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9.1%±1.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Text Box 49"/>
              <p:cNvSpPr/>
              <p:nvPr/>
            </p:nvSpPr>
            <p:spPr>
              <a:xfrm>
                <a:off x="1764720" y="1931400"/>
                <a:ext cx="845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4.6%±1.2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88" name="Group 50"/>
            <p:cNvGrpSpPr/>
            <p:nvPr/>
          </p:nvGrpSpPr>
          <p:grpSpPr>
            <a:xfrm>
              <a:off x="2967120" y="1627200"/>
              <a:ext cx="1026720" cy="496080"/>
              <a:chOff x="2967120" y="1627200"/>
              <a:chExt cx="1026720" cy="496080"/>
            </a:xfrm>
          </p:grpSpPr>
          <p:sp>
            <p:nvSpPr>
              <p:cNvPr id="89" name="Text Box 51"/>
              <p:cNvSpPr/>
              <p:nvPr/>
            </p:nvSpPr>
            <p:spPr>
              <a:xfrm>
                <a:off x="2967120" y="1627200"/>
                <a:ext cx="1026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32.6%±1.1*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Text Box 52"/>
              <p:cNvSpPr/>
              <p:nvPr/>
            </p:nvSpPr>
            <p:spPr>
              <a:xfrm>
                <a:off x="3110760" y="1720080"/>
                <a:ext cx="845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69.9%±0.5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Text Box 53"/>
              <p:cNvSpPr/>
              <p:nvPr/>
            </p:nvSpPr>
            <p:spPr>
              <a:xfrm>
                <a:off x="3096360" y="1823400"/>
                <a:ext cx="845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7.3%±0.5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Text Box 54"/>
              <p:cNvSpPr/>
              <p:nvPr/>
            </p:nvSpPr>
            <p:spPr>
              <a:xfrm>
                <a:off x="3020040" y="1922760"/>
                <a:ext cx="8456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2.8%±1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93" name="Group 55"/>
            <p:cNvGrpSpPr/>
            <p:nvPr/>
          </p:nvGrpSpPr>
          <p:grpSpPr>
            <a:xfrm>
              <a:off x="4222440" y="1630800"/>
              <a:ext cx="1200240" cy="502560"/>
              <a:chOff x="4222440" y="1630800"/>
              <a:chExt cx="1200240" cy="502560"/>
            </a:xfrm>
          </p:grpSpPr>
          <p:sp>
            <p:nvSpPr>
              <p:cNvPr id="94" name="Text Box 56"/>
              <p:cNvSpPr/>
              <p:nvPr/>
            </p:nvSpPr>
            <p:spPr>
              <a:xfrm>
                <a:off x="4222440" y="1630800"/>
                <a:ext cx="1200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4.3%±1.5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Text Box 57"/>
              <p:cNvSpPr/>
              <p:nvPr/>
            </p:nvSpPr>
            <p:spPr>
              <a:xfrm>
                <a:off x="4488120" y="1730160"/>
                <a:ext cx="844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73.3%±0.7*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Text Box 58"/>
              <p:cNvSpPr/>
              <p:nvPr/>
            </p:nvSpPr>
            <p:spPr>
              <a:xfrm>
                <a:off x="4459680" y="1827000"/>
                <a:ext cx="844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6.6%±0.4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Text Box 59"/>
              <p:cNvSpPr/>
              <p:nvPr/>
            </p:nvSpPr>
            <p:spPr>
              <a:xfrm>
                <a:off x="4390560" y="1932840"/>
                <a:ext cx="844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 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20%±1*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pic>
        <p:nvPicPr>
          <p:cNvPr id="98" name="Picture 118" descr=""/>
          <p:cNvPicPr/>
          <p:nvPr/>
        </p:nvPicPr>
        <p:blipFill>
          <a:blip r:embed="rId5"/>
          <a:stretch/>
        </p:blipFill>
        <p:spPr>
          <a:xfrm>
            <a:off x="1282680" y="506520"/>
            <a:ext cx="1162080" cy="107784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120" descr=""/>
          <p:cNvPicPr/>
          <p:nvPr/>
        </p:nvPicPr>
        <p:blipFill>
          <a:blip r:embed="rId6"/>
          <a:stretch/>
        </p:blipFill>
        <p:spPr>
          <a:xfrm>
            <a:off x="4081320" y="506520"/>
            <a:ext cx="1244880" cy="107136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123" descr=""/>
          <p:cNvPicPr/>
          <p:nvPr/>
        </p:nvPicPr>
        <p:blipFill>
          <a:blip r:embed="rId7"/>
          <a:stretch/>
        </p:blipFill>
        <p:spPr>
          <a:xfrm>
            <a:off x="1285920" y="3584520"/>
            <a:ext cx="1162080" cy="1062000"/>
          </a:xfrm>
          <a:prstGeom prst="rect">
            <a:avLst/>
          </a:prstGeom>
          <a:ln w="0">
            <a:noFill/>
          </a:ln>
        </p:spPr>
      </p:pic>
      <p:sp>
        <p:nvSpPr>
          <p:cNvPr id="101" name="Text Box 16"/>
          <p:cNvSpPr/>
          <p:nvPr/>
        </p:nvSpPr>
        <p:spPr>
          <a:xfrm>
            <a:off x="4352760" y="3314880"/>
            <a:ext cx="952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FGFR3-III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Text Box 14"/>
          <p:cNvSpPr/>
          <p:nvPr/>
        </p:nvSpPr>
        <p:spPr>
          <a:xfrm>
            <a:off x="1643040" y="3314880"/>
            <a:ext cx="60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Text Box 15"/>
          <p:cNvSpPr/>
          <p:nvPr/>
        </p:nvSpPr>
        <p:spPr>
          <a:xfrm>
            <a:off x="2930400" y="3314880"/>
            <a:ext cx="8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FGFR3-III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4" name="Picture 179" descr=""/>
          <p:cNvPicPr/>
          <p:nvPr/>
        </p:nvPicPr>
        <p:blipFill>
          <a:blip r:embed="rId8"/>
          <a:stretch/>
        </p:blipFill>
        <p:spPr>
          <a:xfrm>
            <a:off x="2717640" y="3548160"/>
            <a:ext cx="1150920" cy="109044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180" descr=""/>
          <p:cNvPicPr/>
          <p:nvPr/>
        </p:nvPicPr>
        <p:blipFill>
          <a:blip r:embed="rId9"/>
          <a:stretch/>
        </p:blipFill>
        <p:spPr>
          <a:xfrm>
            <a:off x="4170240" y="3592440"/>
            <a:ext cx="1155960" cy="1062000"/>
          </a:xfrm>
          <a:prstGeom prst="rect">
            <a:avLst/>
          </a:prstGeom>
          <a:ln w="0">
            <a:noFill/>
          </a:ln>
        </p:spPr>
      </p:pic>
      <p:grpSp>
        <p:nvGrpSpPr>
          <p:cNvPr id="106" name="Group 189"/>
          <p:cNvGrpSpPr/>
          <p:nvPr/>
        </p:nvGrpSpPr>
        <p:grpSpPr>
          <a:xfrm>
            <a:off x="1274760" y="4729320"/>
            <a:ext cx="3898800" cy="1735560"/>
            <a:chOff x="1274760" y="4729320"/>
            <a:chExt cx="3898800" cy="1735560"/>
          </a:xfrm>
        </p:grpSpPr>
        <p:pic>
          <p:nvPicPr>
            <p:cNvPr id="107" name="Picture 183" descr=""/>
            <p:cNvPicPr/>
            <p:nvPr/>
          </p:nvPicPr>
          <p:blipFill>
            <a:blip r:embed="rId10"/>
            <a:stretch/>
          </p:blipFill>
          <p:spPr>
            <a:xfrm>
              <a:off x="1274760" y="4755600"/>
              <a:ext cx="1162800" cy="136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182" descr=""/>
            <p:cNvPicPr/>
            <p:nvPr/>
          </p:nvPicPr>
          <p:blipFill>
            <a:blip r:embed="rId11"/>
            <a:stretch/>
          </p:blipFill>
          <p:spPr>
            <a:xfrm>
              <a:off x="2554200" y="4730400"/>
              <a:ext cx="1134720" cy="13838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9" name="Group 130"/>
            <p:cNvGrpSpPr/>
            <p:nvPr/>
          </p:nvGrpSpPr>
          <p:grpSpPr>
            <a:xfrm>
              <a:off x="1594440" y="4735440"/>
              <a:ext cx="1108440" cy="609120"/>
              <a:chOff x="1594440" y="4735440"/>
              <a:chExt cx="1108440" cy="609120"/>
            </a:xfrm>
          </p:grpSpPr>
          <p:sp>
            <p:nvSpPr>
              <p:cNvPr id="110" name="Text Box 131"/>
              <p:cNvSpPr/>
              <p:nvPr/>
            </p:nvSpPr>
            <p:spPr>
              <a:xfrm>
                <a:off x="1594440" y="4735440"/>
                <a:ext cx="1108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3.5%±0.2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Text Box 132"/>
              <p:cNvSpPr/>
              <p:nvPr/>
            </p:nvSpPr>
            <p:spPr>
              <a:xfrm>
                <a:off x="1839960" y="4834800"/>
                <a:ext cx="780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49.0%±0.7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Text Box 133"/>
              <p:cNvSpPr/>
              <p:nvPr/>
            </p:nvSpPr>
            <p:spPr>
              <a:xfrm>
                <a:off x="1813320" y="4931640"/>
                <a:ext cx="780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3.2%±0.8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Text Box 134"/>
              <p:cNvSpPr/>
              <p:nvPr/>
            </p:nvSpPr>
            <p:spPr>
              <a:xfrm>
                <a:off x="1749600" y="5037480"/>
                <a:ext cx="780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  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20.2%±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14" name="Group 135"/>
            <p:cNvGrpSpPr/>
            <p:nvPr/>
          </p:nvGrpSpPr>
          <p:grpSpPr>
            <a:xfrm>
              <a:off x="1283760" y="6053040"/>
              <a:ext cx="1150560" cy="400320"/>
              <a:chOff x="1283760" y="6053040"/>
              <a:chExt cx="1150560" cy="400320"/>
            </a:xfrm>
          </p:grpSpPr>
          <p:sp>
            <p:nvSpPr>
              <p:cNvPr id="115" name="Text Box 136"/>
              <p:cNvSpPr/>
              <p:nvPr/>
            </p:nvSpPr>
            <p:spPr>
              <a:xfrm>
                <a:off x="1283760" y="6053040"/>
                <a:ext cx="5119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Text Box 137"/>
              <p:cNvSpPr/>
              <p:nvPr/>
            </p:nvSpPr>
            <p:spPr>
              <a:xfrm>
                <a:off x="1539000" y="6207120"/>
                <a:ext cx="511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Text Box 138"/>
              <p:cNvSpPr/>
              <p:nvPr/>
            </p:nvSpPr>
            <p:spPr>
              <a:xfrm>
                <a:off x="1922400" y="6203520"/>
                <a:ext cx="511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Text Box 139"/>
              <p:cNvSpPr/>
              <p:nvPr/>
            </p:nvSpPr>
            <p:spPr>
              <a:xfrm>
                <a:off x="1775160" y="6054480"/>
                <a:ext cx="456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AutoShape 140"/>
              <p:cNvSpPr/>
              <p:nvPr/>
            </p:nvSpPr>
            <p:spPr>
              <a:xfrm rot="5400000">
                <a:off x="1525680" y="5940360"/>
                <a:ext cx="39600" cy="27180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13320 h 271800"/>
                  <a:gd name="textAreaBottom" fmla="*/ 258480 h 2718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71"/>
                      <a:pt x="21600" y="2141"/>
                    </a:cubicBezTo>
                    <a:lnTo>
                      <a:pt x="21600" y="19459"/>
                    </a:lnTo>
                    <a:cubicBezTo>
                      <a:pt x="21600" y="20530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AutoShape 141"/>
              <p:cNvSpPr/>
              <p:nvPr/>
            </p:nvSpPr>
            <p:spPr>
              <a:xfrm rot="5400000">
                <a:off x="1787040" y="5942520"/>
                <a:ext cx="40680" cy="266760"/>
              </a:xfrm>
              <a:custGeom>
                <a:avLst/>
                <a:gdLst>
                  <a:gd name="textAreaLeft" fmla="*/ 0 w 40680"/>
                  <a:gd name="textAreaRight" fmla="*/ 28440 w 40680"/>
                  <a:gd name="textAreaTop" fmla="*/ 8280 h 266760"/>
                  <a:gd name="textAreaBottom" fmla="*/ 258480 h 266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74"/>
                      <a:pt x="21600" y="1348"/>
                    </a:cubicBezTo>
                    <a:lnTo>
                      <a:pt x="21600" y="20252"/>
                    </a:lnTo>
                    <a:cubicBezTo>
                      <a:pt x="21600" y="20926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AutoShape 142"/>
              <p:cNvSpPr/>
              <p:nvPr/>
            </p:nvSpPr>
            <p:spPr>
              <a:xfrm rot="5400000">
                <a:off x="1982520" y="5946480"/>
                <a:ext cx="34200" cy="26424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560 h 264240"/>
                  <a:gd name="textAreaBottom" fmla="*/ 256680 h 2642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32"/>
                      <a:pt x="21600" y="1264"/>
                    </a:cubicBezTo>
                    <a:lnTo>
                      <a:pt x="21600" y="20336"/>
                    </a:lnTo>
                    <a:cubicBezTo>
                      <a:pt x="21600" y="20968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AutoShape 143"/>
              <p:cNvSpPr/>
              <p:nvPr/>
            </p:nvSpPr>
            <p:spPr>
              <a:xfrm rot="5400000">
                <a:off x="2169720" y="5946480"/>
                <a:ext cx="34200" cy="26424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560 h 264240"/>
                  <a:gd name="textAreaBottom" fmla="*/ 256680 h 2642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32"/>
                      <a:pt x="21600" y="1264"/>
                    </a:cubicBezTo>
                    <a:lnTo>
                      <a:pt x="21600" y="20336"/>
                    </a:lnTo>
                    <a:cubicBezTo>
                      <a:pt x="21600" y="20968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Line 144"/>
              <p:cNvSpPr/>
              <p:nvPr/>
            </p:nvSpPr>
            <p:spPr>
              <a:xfrm>
                <a:off x="1808640" y="609624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" name="Line 145"/>
              <p:cNvSpPr/>
              <p:nvPr/>
            </p:nvSpPr>
            <p:spPr>
              <a:xfrm>
                <a:off x="2185200" y="609624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25" name="Group 146"/>
            <p:cNvGrpSpPr/>
            <p:nvPr/>
          </p:nvGrpSpPr>
          <p:grpSpPr>
            <a:xfrm>
              <a:off x="2570400" y="6059160"/>
              <a:ext cx="1128960" cy="400320"/>
              <a:chOff x="2570400" y="6059160"/>
              <a:chExt cx="1128960" cy="400320"/>
            </a:xfrm>
          </p:grpSpPr>
          <p:sp>
            <p:nvSpPr>
              <p:cNvPr id="126" name="Text Box 147"/>
              <p:cNvSpPr/>
              <p:nvPr/>
            </p:nvSpPr>
            <p:spPr>
              <a:xfrm>
                <a:off x="2570400" y="6059160"/>
                <a:ext cx="50220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" name="Text Box 148"/>
              <p:cNvSpPr/>
              <p:nvPr/>
            </p:nvSpPr>
            <p:spPr>
              <a:xfrm>
                <a:off x="2820960" y="6213240"/>
                <a:ext cx="502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Text Box 149"/>
              <p:cNvSpPr/>
              <p:nvPr/>
            </p:nvSpPr>
            <p:spPr>
              <a:xfrm>
                <a:off x="3197160" y="6209640"/>
                <a:ext cx="502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Text Box 150"/>
              <p:cNvSpPr/>
              <p:nvPr/>
            </p:nvSpPr>
            <p:spPr>
              <a:xfrm>
                <a:off x="3052800" y="6060600"/>
                <a:ext cx="448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AutoShape 151"/>
              <p:cNvSpPr/>
              <p:nvPr/>
            </p:nvSpPr>
            <p:spPr>
              <a:xfrm rot="5400000">
                <a:off x="2808000" y="5946480"/>
                <a:ext cx="39600" cy="27216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12960 h 272160"/>
                  <a:gd name="textAreaBottom" fmla="*/ 259200 h 2721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51"/>
                      <a:pt x="21600" y="2101"/>
                    </a:cubicBezTo>
                    <a:lnTo>
                      <a:pt x="21600" y="19499"/>
                    </a:lnTo>
                    <a:cubicBezTo>
                      <a:pt x="21600" y="20550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AutoShape 152"/>
              <p:cNvSpPr/>
              <p:nvPr/>
            </p:nvSpPr>
            <p:spPr>
              <a:xfrm rot="5400000">
                <a:off x="3064320" y="5948280"/>
                <a:ext cx="40680" cy="267120"/>
              </a:xfrm>
              <a:custGeom>
                <a:avLst/>
                <a:gdLst>
                  <a:gd name="textAreaLeft" fmla="*/ 0 w 40680"/>
                  <a:gd name="textAreaRight" fmla="*/ 28440 w 40680"/>
                  <a:gd name="textAreaTop" fmla="*/ 7920 h 267120"/>
                  <a:gd name="textAreaBottom" fmla="*/ 259200 h 2671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61"/>
                      <a:pt x="21600" y="1322"/>
                    </a:cubicBezTo>
                    <a:lnTo>
                      <a:pt x="21600" y="20278"/>
                    </a:lnTo>
                    <a:cubicBezTo>
                      <a:pt x="21600" y="20939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AutoShape 153"/>
              <p:cNvSpPr/>
              <p:nvPr/>
            </p:nvSpPr>
            <p:spPr>
              <a:xfrm rot="5400000">
                <a:off x="3256200" y="5952600"/>
                <a:ext cx="34200" cy="26424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560 h 264240"/>
                  <a:gd name="textAreaBottom" fmla="*/ 256680 h 2642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20"/>
                      <a:pt x="21600" y="1240"/>
                    </a:cubicBezTo>
                    <a:lnTo>
                      <a:pt x="21600" y="20360"/>
                    </a:lnTo>
                    <a:cubicBezTo>
                      <a:pt x="21600" y="20980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AutoShape 154"/>
              <p:cNvSpPr/>
              <p:nvPr/>
            </p:nvSpPr>
            <p:spPr>
              <a:xfrm rot="5400000">
                <a:off x="3439800" y="5952600"/>
                <a:ext cx="34200" cy="26460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560 h 264600"/>
                  <a:gd name="textAreaBottom" fmla="*/ 257040 h 2646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20"/>
                      <a:pt x="21600" y="1240"/>
                    </a:cubicBezTo>
                    <a:lnTo>
                      <a:pt x="21600" y="20360"/>
                    </a:lnTo>
                    <a:cubicBezTo>
                      <a:pt x="21600" y="20980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Line 155"/>
              <p:cNvSpPr/>
              <p:nvPr/>
            </p:nvSpPr>
            <p:spPr>
              <a:xfrm>
                <a:off x="3085560" y="610236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Line 156"/>
              <p:cNvSpPr/>
              <p:nvPr/>
            </p:nvSpPr>
            <p:spPr>
              <a:xfrm>
                <a:off x="3455280" y="610236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36" name="Group 168"/>
            <p:cNvGrpSpPr/>
            <p:nvPr/>
          </p:nvGrpSpPr>
          <p:grpSpPr>
            <a:xfrm>
              <a:off x="2837160" y="4734000"/>
              <a:ext cx="1108440" cy="609480"/>
              <a:chOff x="2837160" y="4734000"/>
              <a:chExt cx="1108440" cy="609480"/>
            </a:xfrm>
          </p:grpSpPr>
          <p:sp>
            <p:nvSpPr>
              <p:cNvPr id="137" name="Text Box 169"/>
              <p:cNvSpPr/>
              <p:nvPr/>
            </p:nvSpPr>
            <p:spPr>
              <a:xfrm>
                <a:off x="2837160" y="4734000"/>
                <a:ext cx="1108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9.9%±1.5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Text Box 170"/>
              <p:cNvSpPr/>
              <p:nvPr/>
            </p:nvSpPr>
            <p:spPr>
              <a:xfrm>
                <a:off x="3082680" y="4833360"/>
                <a:ext cx="780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44.9%±0.5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Text Box 171"/>
              <p:cNvSpPr/>
              <p:nvPr/>
            </p:nvSpPr>
            <p:spPr>
              <a:xfrm>
                <a:off x="3056040" y="4930200"/>
                <a:ext cx="780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2.2%±0.3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Text Box 172"/>
              <p:cNvSpPr/>
              <p:nvPr/>
            </p:nvSpPr>
            <p:spPr>
              <a:xfrm>
                <a:off x="2992320" y="5036400"/>
                <a:ext cx="780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14.1%±4.2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141" name="Picture 181" descr=""/>
            <p:cNvPicPr/>
            <p:nvPr/>
          </p:nvPicPr>
          <p:blipFill>
            <a:blip r:embed="rId12"/>
            <a:stretch/>
          </p:blipFill>
          <p:spPr>
            <a:xfrm>
              <a:off x="3779640" y="4730400"/>
              <a:ext cx="1156320" cy="1368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2" name="Group 157"/>
            <p:cNvGrpSpPr/>
            <p:nvPr/>
          </p:nvGrpSpPr>
          <p:grpSpPr>
            <a:xfrm>
              <a:off x="3779640" y="6064560"/>
              <a:ext cx="1133280" cy="400320"/>
              <a:chOff x="3779640" y="6064560"/>
              <a:chExt cx="1133280" cy="400320"/>
            </a:xfrm>
          </p:grpSpPr>
          <p:sp>
            <p:nvSpPr>
              <p:cNvPr id="143" name="Text Box 158"/>
              <p:cNvSpPr/>
              <p:nvPr/>
            </p:nvSpPr>
            <p:spPr>
              <a:xfrm>
                <a:off x="3779640" y="6064560"/>
                <a:ext cx="50436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Text Box 159"/>
              <p:cNvSpPr/>
              <p:nvPr/>
            </p:nvSpPr>
            <p:spPr>
              <a:xfrm>
                <a:off x="4031280" y="6218640"/>
                <a:ext cx="504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Text Box 160"/>
              <p:cNvSpPr/>
              <p:nvPr/>
            </p:nvSpPr>
            <p:spPr>
              <a:xfrm>
                <a:off x="4408560" y="6215040"/>
                <a:ext cx="504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Text Box 161"/>
              <p:cNvSpPr/>
              <p:nvPr/>
            </p:nvSpPr>
            <p:spPr>
              <a:xfrm>
                <a:off x="4263840" y="6066000"/>
                <a:ext cx="449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AutoShape 162"/>
              <p:cNvSpPr/>
              <p:nvPr/>
            </p:nvSpPr>
            <p:spPr>
              <a:xfrm rot="5400000">
                <a:off x="4018320" y="5950800"/>
                <a:ext cx="39240" cy="271800"/>
              </a:xfrm>
              <a:custGeom>
                <a:avLst/>
                <a:gdLst>
                  <a:gd name="textAreaLeft" fmla="*/ 0 w 39240"/>
                  <a:gd name="textAreaRight" fmla="*/ 27720 w 39240"/>
                  <a:gd name="textAreaTop" fmla="*/ 12960 h 271800"/>
                  <a:gd name="textAreaBottom" fmla="*/ 258840 h 2718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56"/>
                      <a:pt x="21600" y="2111"/>
                    </a:cubicBezTo>
                    <a:lnTo>
                      <a:pt x="21600" y="19489"/>
                    </a:lnTo>
                    <a:cubicBezTo>
                      <a:pt x="21600" y="20545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AutoShape 163"/>
              <p:cNvSpPr/>
              <p:nvPr/>
            </p:nvSpPr>
            <p:spPr>
              <a:xfrm rot="5400000">
                <a:off x="4276080" y="5952600"/>
                <a:ext cx="40680" cy="267120"/>
              </a:xfrm>
              <a:custGeom>
                <a:avLst/>
                <a:gdLst>
                  <a:gd name="textAreaLeft" fmla="*/ 0 w 40680"/>
                  <a:gd name="textAreaRight" fmla="*/ 28440 w 40680"/>
                  <a:gd name="textAreaTop" fmla="*/ 7920 h 267120"/>
                  <a:gd name="textAreaBottom" fmla="*/ 259200 h 2671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65"/>
                      <a:pt x="21600" y="1329"/>
                    </a:cubicBezTo>
                    <a:lnTo>
                      <a:pt x="21600" y="20271"/>
                    </a:lnTo>
                    <a:cubicBezTo>
                      <a:pt x="21600" y="20936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AutoShape 164"/>
              <p:cNvSpPr/>
              <p:nvPr/>
            </p:nvSpPr>
            <p:spPr>
              <a:xfrm rot="5400000">
                <a:off x="4468680" y="5958000"/>
                <a:ext cx="34200" cy="26424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560 h 264240"/>
                  <a:gd name="textAreaBottom" fmla="*/ 256680 h 2642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23"/>
                      <a:pt x="21600" y="1246"/>
                    </a:cubicBezTo>
                    <a:lnTo>
                      <a:pt x="21600" y="20354"/>
                    </a:lnTo>
                    <a:cubicBezTo>
                      <a:pt x="21600" y="20977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" name="AutoShape 165"/>
              <p:cNvSpPr/>
              <p:nvPr/>
            </p:nvSpPr>
            <p:spPr>
              <a:xfrm rot="5400000">
                <a:off x="4653000" y="5958000"/>
                <a:ext cx="34200" cy="264600"/>
              </a:xfrm>
              <a:custGeom>
                <a:avLst/>
                <a:gdLst>
                  <a:gd name="textAreaLeft" fmla="*/ 0 w 34200"/>
                  <a:gd name="textAreaRight" fmla="*/ 24120 w 34200"/>
                  <a:gd name="textAreaTop" fmla="*/ 7560 h 264600"/>
                  <a:gd name="textAreaBottom" fmla="*/ 257040 h 2646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23"/>
                      <a:pt x="21600" y="1246"/>
                    </a:cubicBezTo>
                    <a:lnTo>
                      <a:pt x="21600" y="20354"/>
                    </a:lnTo>
                    <a:cubicBezTo>
                      <a:pt x="21600" y="20977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Line 166"/>
              <p:cNvSpPr/>
              <p:nvPr/>
            </p:nvSpPr>
            <p:spPr>
              <a:xfrm>
                <a:off x="4296960" y="610776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" name="Line 167"/>
              <p:cNvSpPr/>
              <p:nvPr/>
            </p:nvSpPr>
            <p:spPr>
              <a:xfrm>
                <a:off x="4667760" y="610776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53" name="Group 173"/>
            <p:cNvGrpSpPr/>
            <p:nvPr/>
          </p:nvGrpSpPr>
          <p:grpSpPr>
            <a:xfrm>
              <a:off x="4065120" y="4729320"/>
              <a:ext cx="1108440" cy="609120"/>
              <a:chOff x="4065120" y="4729320"/>
              <a:chExt cx="1108440" cy="609120"/>
            </a:xfrm>
          </p:grpSpPr>
          <p:sp>
            <p:nvSpPr>
              <p:cNvPr id="154" name="Text Box 174"/>
              <p:cNvSpPr/>
              <p:nvPr/>
            </p:nvSpPr>
            <p:spPr>
              <a:xfrm>
                <a:off x="4065120" y="4729320"/>
                <a:ext cx="1108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7.1%±0.1*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" name="Text Box 175"/>
              <p:cNvSpPr/>
              <p:nvPr/>
            </p:nvSpPr>
            <p:spPr>
              <a:xfrm>
                <a:off x="4310640" y="4828680"/>
                <a:ext cx="780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44.6%±1.4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Text Box 176"/>
              <p:cNvSpPr/>
              <p:nvPr/>
            </p:nvSpPr>
            <p:spPr>
              <a:xfrm>
                <a:off x="4284000" y="4925520"/>
                <a:ext cx="780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4.1%±1.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Text Box 177"/>
              <p:cNvSpPr/>
              <p:nvPr/>
            </p:nvSpPr>
            <p:spPr>
              <a:xfrm>
                <a:off x="4220280" y="5031360"/>
                <a:ext cx="7804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   </a:t>
                </a: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 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16.3%±1.7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158" name="Groupe 298"/>
          <p:cNvGrpSpPr/>
          <p:nvPr/>
        </p:nvGrpSpPr>
        <p:grpSpPr>
          <a:xfrm>
            <a:off x="1133640" y="6392880"/>
            <a:ext cx="4524120" cy="3143520"/>
            <a:chOff x="1133640" y="6392880"/>
            <a:chExt cx="4524120" cy="3143520"/>
          </a:xfrm>
        </p:grpSpPr>
        <p:pic>
          <p:nvPicPr>
            <p:cNvPr id="159" name="Picture 70" descr=""/>
            <p:cNvPicPr/>
            <p:nvPr/>
          </p:nvPicPr>
          <p:blipFill>
            <a:blip r:embed="rId13"/>
            <a:stretch/>
          </p:blipFill>
          <p:spPr>
            <a:xfrm>
              <a:off x="2625840" y="6648120"/>
              <a:ext cx="1306080" cy="105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0" name="Picture 67" descr=""/>
            <p:cNvPicPr/>
            <p:nvPr/>
          </p:nvPicPr>
          <p:blipFill>
            <a:blip r:embed="rId14"/>
            <a:stretch/>
          </p:blipFill>
          <p:spPr>
            <a:xfrm>
              <a:off x="4095720" y="7746480"/>
              <a:ext cx="1254600" cy="1421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1" name="Picture 66" descr=""/>
            <p:cNvPicPr/>
            <p:nvPr/>
          </p:nvPicPr>
          <p:blipFill>
            <a:blip r:embed="rId15"/>
            <a:stretch/>
          </p:blipFill>
          <p:spPr>
            <a:xfrm>
              <a:off x="2706120" y="7746480"/>
              <a:ext cx="1250280" cy="1429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2" name="Picture 65" descr=""/>
            <p:cNvPicPr/>
            <p:nvPr/>
          </p:nvPicPr>
          <p:blipFill>
            <a:blip r:embed="rId16"/>
            <a:stretch/>
          </p:blipFill>
          <p:spPr>
            <a:xfrm>
              <a:off x="1330200" y="7704000"/>
              <a:ext cx="1271160" cy="145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3" name="Text Box 16"/>
            <p:cNvSpPr/>
            <p:nvPr/>
          </p:nvSpPr>
          <p:spPr>
            <a:xfrm>
              <a:off x="4333320" y="6396840"/>
              <a:ext cx="1021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FGFR3-III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Text Box 14"/>
            <p:cNvSpPr/>
            <p:nvPr/>
          </p:nvSpPr>
          <p:spPr>
            <a:xfrm>
              <a:off x="1696680" y="6397920"/>
              <a:ext cx="961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Text Box 15"/>
            <p:cNvSpPr/>
            <p:nvPr/>
          </p:nvSpPr>
          <p:spPr>
            <a:xfrm>
              <a:off x="2946960" y="6392880"/>
              <a:ext cx="107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FGFR3-IIIb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Text Box 11"/>
            <p:cNvSpPr/>
            <p:nvPr/>
          </p:nvSpPr>
          <p:spPr>
            <a:xfrm rot="16200000">
              <a:off x="826560" y="8304120"/>
              <a:ext cx="86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Counts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67" name="Group 12"/>
            <p:cNvGrpSpPr/>
            <p:nvPr/>
          </p:nvGrpSpPr>
          <p:grpSpPr>
            <a:xfrm>
              <a:off x="1313640" y="9117360"/>
              <a:ext cx="1369440" cy="406800"/>
              <a:chOff x="1313640" y="9117360"/>
              <a:chExt cx="1369440" cy="406800"/>
            </a:xfrm>
          </p:grpSpPr>
          <p:sp>
            <p:nvSpPr>
              <p:cNvPr id="168" name="Text Box 13"/>
              <p:cNvSpPr/>
              <p:nvPr/>
            </p:nvSpPr>
            <p:spPr>
              <a:xfrm>
                <a:off x="1313640" y="9117360"/>
                <a:ext cx="609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Text Box 14"/>
              <p:cNvSpPr/>
              <p:nvPr/>
            </p:nvSpPr>
            <p:spPr>
              <a:xfrm>
                <a:off x="1617480" y="9277920"/>
                <a:ext cx="609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" name="Text Box 15"/>
              <p:cNvSpPr/>
              <p:nvPr/>
            </p:nvSpPr>
            <p:spPr>
              <a:xfrm>
                <a:off x="2073600" y="9274320"/>
                <a:ext cx="609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" name="Text Box 16"/>
              <p:cNvSpPr/>
              <p:nvPr/>
            </p:nvSpPr>
            <p:spPr>
              <a:xfrm>
                <a:off x="1898640" y="9118800"/>
                <a:ext cx="54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" name="AutoShape 17"/>
              <p:cNvSpPr/>
              <p:nvPr/>
            </p:nvSpPr>
            <p:spPr>
              <a:xfrm rot="5400000">
                <a:off x="1606320" y="8985240"/>
                <a:ext cx="41040" cy="310320"/>
              </a:xfrm>
              <a:custGeom>
                <a:avLst/>
                <a:gdLst>
                  <a:gd name="textAreaLeft" fmla="*/ 0 w 41040"/>
                  <a:gd name="textAreaRight" fmla="*/ 28800 w 41040"/>
                  <a:gd name="textAreaTop" fmla="*/ 15840 h 310320"/>
                  <a:gd name="textAreaBottom" fmla="*/ 294480 h 310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119"/>
                      <a:pt x="21600" y="2237"/>
                    </a:cubicBezTo>
                    <a:lnTo>
                      <a:pt x="21600" y="19363"/>
                    </a:lnTo>
                    <a:cubicBezTo>
                      <a:pt x="21600" y="20482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" name="AutoShape 18"/>
              <p:cNvSpPr/>
              <p:nvPr/>
            </p:nvSpPr>
            <p:spPr>
              <a:xfrm rot="5400000">
                <a:off x="1917000" y="8988120"/>
                <a:ext cx="42480" cy="303840"/>
              </a:xfrm>
              <a:custGeom>
                <a:avLst/>
                <a:gdLst>
                  <a:gd name="textAreaLeft" fmla="*/ 0 w 42480"/>
                  <a:gd name="textAreaRight" fmla="*/ 29880 w 42480"/>
                  <a:gd name="textAreaTop" fmla="*/ 9720 h 303840"/>
                  <a:gd name="textAreaBottom" fmla="*/ 294120 h 3038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705"/>
                      <a:pt x="21600" y="1409"/>
                    </a:cubicBezTo>
                    <a:lnTo>
                      <a:pt x="21600" y="20191"/>
                    </a:lnTo>
                    <a:cubicBezTo>
                      <a:pt x="21600" y="20896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" name="AutoShape 19"/>
              <p:cNvSpPr/>
              <p:nvPr/>
            </p:nvSpPr>
            <p:spPr>
              <a:xfrm rot="5400000">
                <a:off x="2148480" y="8994600"/>
                <a:ext cx="36000" cy="302400"/>
              </a:xfrm>
              <a:custGeom>
                <a:avLst/>
                <a:gdLst>
                  <a:gd name="textAreaLeft" fmla="*/ 0 w 36000"/>
                  <a:gd name="textAreaRight" fmla="*/ 25200 w 36000"/>
                  <a:gd name="textAreaTop" fmla="*/ 9000 h 302400"/>
                  <a:gd name="textAreaBottom" fmla="*/ 293400 h 3024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58"/>
                      <a:pt x="21600" y="1316"/>
                    </a:cubicBezTo>
                    <a:lnTo>
                      <a:pt x="21600" y="20284"/>
                    </a:lnTo>
                    <a:cubicBezTo>
                      <a:pt x="21600" y="20942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" name="AutoShape 20"/>
              <p:cNvSpPr/>
              <p:nvPr/>
            </p:nvSpPr>
            <p:spPr>
              <a:xfrm rot="5400000">
                <a:off x="2370960" y="8994600"/>
                <a:ext cx="36000" cy="302400"/>
              </a:xfrm>
              <a:custGeom>
                <a:avLst/>
                <a:gdLst>
                  <a:gd name="textAreaLeft" fmla="*/ 0 w 36000"/>
                  <a:gd name="textAreaRight" fmla="*/ 25200 w 36000"/>
                  <a:gd name="textAreaTop" fmla="*/ 9000 h 302400"/>
                  <a:gd name="textAreaBottom" fmla="*/ 293400 h 3024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58"/>
                      <a:pt x="21600" y="1316"/>
                    </a:cubicBezTo>
                    <a:lnTo>
                      <a:pt x="21600" y="20284"/>
                    </a:lnTo>
                    <a:cubicBezTo>
                      <a:pt x="21600" y="20942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" name="Line 21"/>
              <p:cNvSpPr/>
              <p:nvPr/>
            </p:nvSpPr>
            <p:spPr>
              <a:xfrm>
                <a:off x="1938600" y="9162360"/>
                <a:ext cx="0" cy="1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" name="Line 22"/>
              <p:cNvSpPr/>
              <p:nvPr/>
            </p:nvSpPr>
            <p:spPr>
              <a:xfrm>
                <a:off x="2386800" y="9162360"/>
                <a:ext cx="0" cy="1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78" name="Group 23"/>
            <p:cNvGrpSpPr/>
            <p:nvPr/>
          </p:nvGrpSpPr>
          <p:grpSpPr>
            <a:xfrm>
              <a:off x="2669760" y="9129600"/>
              <a:ext cx="1436040" cy="406800"/>
              <a:chOff x="2669760" y="9129600"/>
              <a:chExt cx="1436040" cy="406800"/>
            </a:xfrm>
          </p:grpSpPr>
          <p:sp>
            <p:nvSpPr>
              <p:cNvPr id="179" name="Text Box 24"/>
              <p:cNvSpPr/>
              <p:nvPr/>
            </p:nvSpPr>
            <p:spPr>
              <a:xfrm>
                <a:off x="2669760" y="9129600"/>
                <a:ext cx="639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" name="Text Box 25"/>
              <p:cNvSpPr/>
              <p:nvPr/>
            </p:nvSpPr>
            <p:spPr>
              <a:xfrm>
                <a:off x="2988360" y="9290160"/>
                <a:ext cx="639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" name="Text Box 26"/>
              <p:cNvSpPr/>
              <p:nvPr/>
            </p:nvSpPr>
            <p:spPr>
              <a:xfrm>
                <a:off x="3466800" y="9286560"/>
                <a:ext cx="639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" name="Text Box 27"/>
              <p:cNvSpPr/>
              <p:nvPr/>
            </p:nvSpPr>
            <p:spPr>
              <a:xfrm>
                <a:off x="3283200" y="9131040"/>
                <a:ext cx="569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" name="AutoShape 28"/>
              <p:cNvSpPr/>
              <p:nvPr/>
            </p:nvSpPr>
            <p:spPr>
              <a:xfrm rot="5400000">
                <a:off x="2976120" y="8998200"/>
                <a:ext cx="41040" cy="310680"/>
              </a:xfrm>
              <a:custGeom>
                <a:avLst/>
                <a:gdLst>
                  <a:gd name="textAreaLeft" fmla="*/ 0 w 41040"/>
                  <a:gd name="textAreaRight" fmla="*/ 28800 w 41040"/>
                  <a:gd name="textAreaTop" fmla="*/ 16560 h 310680"/>
                  <a:gd name="textAreaBottom" fmla="*/ 294120 h 310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171"/>
                      <a:pt x="21600" y="2341"/>
                    </a:cubicBezTo>
                    <a:lnTo>
                      <a:pt x="21600" y="19259"/>
                    </a:lnTo>
                    <a:cubicBezTo>
                      <a:pt x="21600" y="20430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4" name="AutoShape 29"/>
              <p:cNvSpPr/>
              <p:nvPr/>
            </p:nvSpPr>
            <p:spPr>
              <a:xfrm rot="5400000">
                <a:off x="3302280" y="9001080"/>
                <a:ext cx="42480" cy="304200"/>
              </a:xfrm>
              <a:custGeom>
                <a:avLst/>
                <a:gdLst>
                  <a:gd name="textAreaLeft" fmla="*/ 0 w 42480"/>
                  <a:gd name="textAreaRight" fmla="*/ 29880 w 42480"/>
                  <a:gd name="textAreaTop" fmla="*/ 10080 h 304200"/>
                  <a:gd name="textAreaBottom" fmla="*/ 294120 h 304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738"/>
                      <a:pt x="21600" y="1476"/>
                    </a:cubicBezTo>
                    <a:lnTo>
                      <a:pt x="21600" y="20124"/>
                    </a:lnTo>
                    <a:cubicBezTo>
                      <a:pt x="21600" y="20862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5" name="AutoShape 30"/>
              <p:cNvSpPr/>
              <p:nvPr/>
            </p:nvSpPr>
            <p:spPr>
              <a:xfrm rot="5400000">
                <a:off x="3546720" y="9005040"/>
                <a:ext cx="35640" cy="302760"/>
              </a:xfrm>
              <a:custGeom>
                <a:avLst/>
                <a:gdLst>
                  <a:gd name="textAreaLeft" fmla="*/ 0 w 35640"/>
                  <a:gd name="textAreaRight" fmla="*/ 25200 w 35640"/>
                  <a:gd name="textAreaTop" fmla="*/ 9360 h 302760"/>
                  <a:gd name="textAreaBottom" fmla="*/ 293400 h 302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90"/>
                      <a:pt x="21600" y="1379"/>
                    </a:cubicBezTo>
                    <a:lnTo>
                      <a:pt x="21600" y="20221"/>
                    </a:lnTo>
                    <a:cubicBezTo>
                      <a:pt x="21600" y="20911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AutoShape 31"/>
              <p:cNvSpPr/>
              <p:nvPr/>
            </p:nvSpPr>
            <p:spPr>
              <a:xfrm rot="5400000">
                <a:off x="3780000" y="9005040"/>
                <a:ext cx="35640" cy="302760"/>
              </a:xfrm>
              <a:custGeom>
                <a:avLst/>
                <a:gdLst>
                  <a:gd name="textAreaLeft" fmla="*/ 0 w 35640"/>
                  <a:gd name="textAreaRight" fmla="*/ 25200 w 35640"/>
                  <a:gd name="textAreaTop" fmla="*/ 9360 h 302760"/>
                  <a:gd name="textAreaBottom" fmla="*/ 293400 h 3027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90"/>
                      <a:pt x="21600" y="1379"/>
                    </a:cubicBezTo>
                    <a:lnTo>
                      <a:pt x="21600" y="20221"/>
                    </a:lnTo>
                    <a:cubicBezTo>
                      <a:pt x="21600" y="20911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7" name="Line 32"/>
              <p:cNvSpPr/>
              <p:nvPr/>
            </p:nvSpPr>
            <p:spPr>
              <a:xfrm>
                <a:off x="3325320" y="9174600"/>
                <a:ext cx="0" cy="1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8" name="Line 33"/>
              <p:cNvSpPr/>
              <p:nvPr/>
            </p:nvSpPr>
            <p:spPr>
              <a:xfrm>
                <a:off x="3795120" y="9174600"/>
                <a:ext cx="0" cy="1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89" name="Group 34"/>
            <p:cNvGrpSpPr/>
            <p:nvPr/>
          </p:nvGrpSpPr>
          <p:grpSpPr>
            <a:xfrm>
              <a:off x="4076280" y="9122760"/>
              <a:ext cx="1331640" cy="406800"/>
              <a:chOff x="4076280" y="9122760"/>
              <a:chExt cx="1331640" cy="406800"/>
            </a:xfrm>
          </p:grpSpPr>
          <p:sp>
            <p:nvSpPr>
              <p:cNvPr id="190" name="Text Box 35"/>
              <p:cNvSpPr/>
              <p:nvPr/>
            </p:nvSpPr>
            <p:spPr>
              <a:xfrm>
                <a:off x="4076280" y="9122760"/>
                <a:ext cx="592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1" name="Text Box 36"/>
              <p:cNvSpPr/>
              <p:nvPr/>
            </p:nvSpPr>
            <p:spPr>
              <a:xfrm>
                <a:off x="4371840" y="9283320"/>
                <a:ext cx="592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2" name="Text Box 37"/>
              <p:cNvSpPr/>
              <p:nvPr/>
            </p:nvSpPr>
            <p:spPr>
              <a:xfrm>
                <a:off x="4815360" y="9279720"/>
                <a:ext cx="592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3" name="Text Box 38"/>
              <p:cNvSpPr/>
              <p:nvPr/>
            </p:nvSpPr>
            <p:spPr>
              <a:xfrm>
                <a:off x="4645080" y="9124200"/>
                <a:ext cx="528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AutoShape 39"/>
              <p:cNvSpPr/>
              <p:nvPr/>
            </p:nvSpPr>
            <p:spPr>
              <a:xfrm rot="5400000">
                <a:off x="4359960" y="8991720"/>
                <a:ext cx="41040" cy="310320"/>
              </a:xfrm>
              <a:custGeom>
                <a:avLst/>
                <a:gdLst>
                  <a:gd name="textAreaLeft" fmla="*/ 0 w 41040"/>
                  <a:gd name="textAreaRight" fmla="*/ 28800 w 41040"/>
                  <a:gd name="textAreaTop" fmla="*/ 15480 h 310320"/>
                  <a:gd name="textAreaBottom" fmla="*/ 294840 h 310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1086"/>
                      <a:pt x="21600" y="2172"/>
                    </a:cubicBezTo>
                    <a:lnTo>
                      <a:pt x="21600" y="19428"/>
                    </a:lnTo>
                    <a:cubicBezTo>
                      <a:pt x="21600" y="20514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5" name="AutoShape 40"/>
              <p:cNvSpPr/>
              <p:nvPr/>
            </p:nvSpPr>
            <p:spPr>
              <a:xfrm rot="5400000">
                <a:off x="4662000" y="8993160"/>
                <a:ext cx="42480" cy="304200"/>
              </a:xfrm>
              <a:custGeom>
                <a:avLst/>
                <a:gdLst>
                  <a:gd name="textAreaLeft" fmla="*/ 0 w 42480"/>
                  <a:gd name="textAreaRight" fmla="*/ 29880 w 42480"/>
                  <a:gd name="textAreaTop" fmla="*/ 9360 h 304200"/>
                  <a:gd name="textAreaBottom" fmla="*/ 294840 h 304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84"/>
                      <a:pt x="21600" y="1368"/>
                    </a:cubicBezTo>
                    <a:lnTo>
                      <a:pt x="21600" y="20232"/>
                    </a:lnTo>
                    <a:cubicBezTo>
                      <a:pt x="21600" y="20916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6" name="AutoShape 41"/>
              <p:cNvSpPr/>
              <p:nvPr/>
            </p:nvSpPr>
            <p:spPr>
              <a:xfrm rot="5400000">
                <a:off x="4888440" y="8998560"/>
                <a:ext cx="35640" cy="301680"/>
              </a:xfrm>
              <a:custGeom>
                <a:avLst/>
                <a:gdLst>
                  <a:gd name="textAreaLeft" fmla="*/ 0 w 35640"/>
                  <a:gd name="textAreaRight" fmla="*/ 25200 w 35640"/>
                  <a:gd name="textAreaTop" fmla="*/ 8640 h 301680"/>
                  <a:gd name="textAreaBottom" fmla="*/ 293040 h 301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42"/>
                      <a:pt x="21600" y="1283"/>
                    </a:cubicBezTo>
                    <a:lnTo>
                      <a:pt x="21600" y="20317"/>
                    </a:lnTo>
                    <a:cubicBezTo>
                      <a:pt x="21600" y="20959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7" name="AutoShape 42"/>
              <p:cNvSpPr/>
              <p:nvPr/>
            </p:nvSpPr>
            <p:spPr>
              <a:xfrm rot="5400000">
                <a:off x="5104800" y="8998920"/>
                <a:ext cx="35640" cy="301320"/>
              </a:xfrm>
              <a:custGeom>
                <a:avLst/>
                <a:gdLst>
                  <a:gd name="textAreaLeft" fmla="*/ 0 w 35640"/>
                  <a:gd name="textAreaRight" fmla="*/ 25200 w 35640"/>
                  <a:gd name="textAreaTop" fmla="*/ 8640 h 301320"/>
                  <a:gd name="textAreaBottom" fmla="*/ 292680 h 301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642"/>
                      <a:pt x="21600" y="1283"/>
                    </a:cubicBezTo>
                    <a:lnTo>
                      <a:pt x="21600" y="20317"/>
                    </a:lnTo>
                    <a:cubicBezTo>
                      <a:pt x="21600" y="20959"/>
                      <a:pt x="108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8" name="Line 43"/>
              <p:cNvSpPr/>
              <p:nvPr/>
            </p:nvSpPr>
            <p:spPr>
              <a:xfrm>
                <a:off x="4683960" y="9167760"/>
                <a:ext cx="0" cy="1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9" name="Line 44"/>
              <p:cNvSpPr/>
              <p:nvPr/>
            </p:nvSpPr>
            <p:spPr>
              <a:xfrm>
                <a:off x="5119920" y="9167760"/>
                <a:ext cx="0" cy="1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00" name="Group 45"/>
            <p:cNvGrpSpPr/>
            <p:nvPr/>
          </p:nvGrpSpPr>
          <p:grpSpPr>
            <a:xfrm>
              <a:off x="1661760" y="7756920"/>
              <a:ext cx="1263600" cy="515520"/>
              <a:chOff x="1661760" y="7756920"/>
              <a:chExt cx="1263600" cy="515520"/>
            </a:xfrm>
          </p:grpSpPr>
          <p:sp>
            <p:nvSpPr>
              <p:cNvPr id="201" name="Text Box 46"/>
              <p:cNvSpPr/>
              <p:nvPr/>
            </p:nvSpPr>
            <p:spPr>
              <a:xfrm>
                <a:off x="1661760" y="7756920"/>
                <a:ext cx="1263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4.9%±0.5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2" name="Text Box 47"/>
              <p:cNvSpPr/>
              <p:nvPr/>
            </p:nvSpPr>
            <p:spPr>
              <a:xfrm>
                <a:off x="1918800" y="786060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77.1±1.4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3" name="Text Box 48"/>
              <p:cNvSpPr/>
              <p:nvPr/>
            </p:nvSpPr>
            <p:spPr>
              <a:xfrm>
                <a:off x="1918800" y="796140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2%±0.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4" name="Text Box 49"/>
              <p:cNvSpPr/>
              <p:nvPr/>
            </p:nvSpPr>
            <p:spPr>
              <a:xfrm>
                <a:off x="1891440" y="807192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 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20.8%±1.6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05" name="Group 50"/>
            <p:cNvGrpSpPr/>
            <p:nvPr/>
          </p:nvGrpSpPr>
          <p:grpSpPr>
            <a:xfrm>
              <a:off x="3051360" y="7759800"/>
              <a:ext cx="1263600" cy="515520"/>
              <a:chOff x="3051360" y="7759800"/>
              <a:chExt cx="1263600" cy="515520"/>
            </a:xfrm>
          </p:grpSpPr>
          <p:sp>
            <p:nvSpPr>
              <p:cNvPr id="206" name="Text Box 51"/>
              <p:cNvSpPr/>
              <p:nvPr/>
            </p:nvSpPr>
            <p:spPr>
              <a:xfrm>
                <a:off x="3051360" y="7759800"/>
                <a:ext cx="1263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2.1%±0.7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7" name="Text Box 52"/>
              <p:cNvSpPr/>
              <p:nvPr/>
            </p:nvSpPr>
            <p:spPr>
              <a:xfrm>
                <a:off x="3308400" y="786348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73.5±1.8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8" name="Text Box 53"/>
              <p:cNvSpPr/>
              <p:nvPr/>
            </p:nvSpPr>
            <p:spPr>
              <a:xfrm>
                <a:off x="3399480" y="796428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5.6%±0.5*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9" name="Text Box 54"/>
              <p:cNvSpPr/>
              <p:nvPr/>
            </p:nvSpPr>
            <p:spPr>
              <a:xfrm>
                <a:off x="3281400" y="807480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 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20.9%±1.5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10" name="Group 55"/>
            <p:cNvGrpSpPr/>
            <p:nvPr/>
          </p:nvGrpSpPr>
          <p:grpSpPr>
            <a:xfrm>
              <a:off x="4394160" y="7758360"/>
              <a:ext cx="1263600" cy="522000"/>
              <a:chOff x="4394160" y="7758360"/>
              <a:chExt cx="1263600" cy="522000"/>
            </a:xfrm>
          </p:grpSpPr>
          <p:sp>
            <p:nvSpPr>
              <p:cNvPr id="211" name="Text Box 56"/>
              <p:cNvSpPr/>
              <p:nvPr/>
            </p:nvSpPr>
            <p:spPr>
              <a:xfrm>
                <a:off x="4394160" y="7758360"/>
                <a:ext cx="1263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ub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8%±1.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2" name="Text Box 57"/>
              <p:cNvSpPr/>
              <p:nvPr/>
            </p:nvSpPr>
            <p:spPr>
              <a:xfrm>
                <a:off x="4673880" y="786204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1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74.3±2.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3" name="Text Box 58"/>
              <p:cNvSpPr/>
              <p:nvPr/>
            </p:nvSpPr>
            <p:spPr>
              <a:xfrm>
                <a:off x="4764600" y="796968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S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  3.4%±0.2***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4" name="Text Box 59"/>
              <p:cNvSpPr/>
              <p:nvPr/>
            </p:nvSpPr>
            <p:spPr>
              <a:xfrm>
                <a:off x="4654080" y="8079840"/>
                <a:ext cx="8895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437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G2/M </a:t>
                </a:r>
                <a:r>
                  <a:rPr b="0" lang="fr-FR" sz="700" spc="-1" strike="noStrike">
                    <a:solidFill>
                      <a:srgbClr val="000000"/>
                    </a:solidFill>
                    <a:latin typeface="Calibri"/>
                    <a:ea typeface="Calibri"/>
                  </a:rPr>
                  <a:t>22.2%±1.9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215" name="Picture 69" descr=""/>
            <p:cNvPicPr/>
            <p:nvPr/>
          </p:nvPicPr>
          <p:blipFill>
            <a:blip r:embed="rId17"/>
            <a:stretch/>
          </p:blipFill>
          <p:spPr>
            <a:xfrm>
              <a:off x="1265040" y="6666480"/>
              <a:ext cx="1280520" cy="1037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6" name="Picture 71" descr=""/>
            <p:cNvPicPr/>
            <p:nvPr/>
          </p:nvPicPr>
          <p:blipFill>
            <a:blip r:embed="rId18"/>
            <a:stretch/>
          </p:blipFill>
          <p:spPr>
            <a:xfrm>
              <a:off x="3986640" y="6630840"/>
              <a:ext cx="1366560" cy="10648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17" name="Rectangle 360"/>
          <p:cNvSpPr/>
          <p:nvPr/>
        </p:nvSpPr>
        <p:spPr>
          <a:xfrm>
            <a:off x="1182600" y="212760"/>
            <a:ext cx="4240440" cy="31021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Rectangle 361"/>
          <p:cNvSpPr/>
          <p:nvPr/>
        </p:nvSpPr>
        <p:spPr>
          <a:xfrm>
            <a:off x="1182600" y="3313080"/>
            <a:ext cx="4240440" cy="31021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Rectangle 362"/>
          <p:cNvSpPr/>
          <p:nvPr/>
        </p:nvSpPr>
        <p:spPr>
          <a:xfrm>
            <a:off x="1182600" y="6416640"/>
            <a:ext cx="4240440" cy="31021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ZoneTexte 363"/>
          <p:cNvSpPr/>
          <p:nvPr/>
        </p:nvSpPr>
        <p:spPr>
          <a:xfrm>
            <a:off x="1205640" y="2286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ZoneTexte 364"/>
          <p:cNvSpPr/>
          <p:nvPr/>
        </p:nvSpPr>
        <p:spPr>
          <a:xfrm>
            <a:off x="1209600" y="331488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ZoneTexte 365"/>
          <p:cNvSpPr/>
          <p:nvPr/>
        </p:nvSpPr>
        <p:spPr>
          <a:xfrm>
            <a:off x="1211760" y="641988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ZoneTexte 183"/>
          <p:cNvSpPr/>
          <p:nvPr/>
        </p:nvSpPr>
        <p:spPr>
          <a:xfrm>
            <a:off x="742320" y="9491760"/>
            <a:ext cx="160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4T13:22:32Z</dcterms:created>
  <dc:creator>Marie</dc:creator>
  <dc:description/>
  <dc:language>en-US</dc:language>
  <cp:lastModifiedBy>Sandrine</cp:lastModifiedBy>
  <dcterms:modified xsi:type="dcterms:W3CDTF">2013-06-06T13:14:19Z</dcterms:modified>
  <cp:revision>387</cp:revision>
  <dc:subject/>
  <dc:title>Diapositive 1</dc:title>
</cp:coreProperties>
</file>